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62" r:id="rId4"/>
    <p:sldId id="263" r:id="rId5"/>
    <p:sldId id="264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2094" y="3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3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3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20714"/>
            <a:ext cx="691276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lton et al (2025) Diabetologia DOI 10.1007/s00125-025-06406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1520" y="190381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Overview of disaster-related actions recommended for people with diabetes and their families according to the prevention, preparation, response and recovery approach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8DAE441-94D9-5605-33C9-AE279BB1B7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1800" y="1029733"/>
            <a:ext cx="3600400" cy="4775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87841"/>
            <a:ext cx="71287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lton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06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188640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Overview of disaster-related actions recommended for healthcare professionals according to the prevention, preparation, response and recovery approach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FB051E5-7F2E-681D-7600-E76D5E1A89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0984" y="968169"/>
            <a:ext cx="2762033" cy="4909103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805264"/>
            <a:ext cx="69847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lton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06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520" y="188640"/>
            <a:ext cx="8748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Overview of disaster-related actions recommended for diabetes associations and governments according to the prevention, preparation, response and recovery approach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6EE8676-3210-6BDE-937D-B75C44CA3B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21965" y="944724"/>
            <a:ext cx="2700071" cy="4968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2C82A8-9318-D481-737C-37603E1F79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F9928D9-27FA-7ACD-0C24-27371D422DC7}"/>
              </a:ext>
            </a:extLst>
          </p:cNvPr>
          <p:cNvSpPr txBox="1"/>
          <p:nvPr/>
        </p:nvSpPr>
        <p:spPr>
          <a:xfrm>
            <a:off x="107504" y="5941729"/>
            <a:ext cx="69847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lton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06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produced from </a:t>
            </a:r>
            <a:r>
              <a:rPr kumimoji="0" lang="en-GB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ebrehiwet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3) (DOI 10.1001/jamanetworkopen.2023.31745) </a:t>
            </a:r>
          </a:p>
          <a:p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F6987BB-7835-D4C7-A84A-66A21609C541}"/>
              </a:ext>
            </a:extLst>
          </p:cNvPr>
          <p:cNvSpPr txBox="1"/>
          <p:nvPr/>
        </p:nvSpPr>
        <p:spPr>
          <a:xfrm>
            <a:off x="395536" y="33265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hanges in the use of services by individuals with type 1 diabetes before and during the Tigray war</a:t>
            </a:r>
            <a:endParaRPr lang="en-GB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C9F77800-53D7-A47E-DE0B-A493897CC44A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D6A3993-D73D-9223-6821-14B6883DC1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857" y="1556792"/>
            <a:ext cx="8082287" cy="3888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9023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E3B68F-785A-CE81-9755-BDFFEFCA34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FE080A2-064E-557D-22D6-5E2116AAF98E}"/>
              </a:ext>
            </a:extLst>
          </p:cNvPr>
          <p:cNvSpPr txBox="1"/>
          <p:nvPr/>
        </p:nvSpPr>
        <p:spPr>
          <a:xfrm>
            <a:off x="107504" y="5757063"/>
            <a:ext cx="712879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oulton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06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148DC3-B877-7C71-83B9-9E5F5AD26B81}"/>
              </a:ext>
            </a:extLst>
          </p:cNvPr>
          <p:cNvSpPr txBox="1"/>
          <p:nvPr/>
        </p:nvSpPr>
        <p:spPr>
          <a:xfrm>
            <a:off x="179512" y="188640"/>
            <a:ext cx="87484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chematic </a:t>
            </a:r>
            <a:r>
              <a:rPr lang="en-US" b="1" dirty="0" err="1"/>
              <a:t>summarising</a:t>
            </a:r>
            <a:r>
              <a:rPr lang="en-US" b="1" dirty="0"/>
              <a:t> the potential consequences of natural and man-made disasters and the resources available to prevent, prepare for, respond to and recover from a disaster</a:t>
            </a:r>
            <a:endParaRPr lang="en-GB" b="1" dirty="0"/>
          </a:p>
        </p:txBody>
      </p:sp>
      <p:pic>
        <p:nvPicPr>
          <p:cNvPr id="9" name="Picture 8" descr="diabetologia logo.tif">
            <a:extLst>
              <a:ext uri="{FF2B5EF4-FFF2-40B4-BE49-F238E27FC236}">
                <a16:creationId xmlns:a16="http://schemas.microsoft.com/office/drawing/2014/main" id="{BBDCDF82-16E2-E931-920E-8F70A35D9C9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9C5BF08-5725-97EC-08F4-680B09C782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0605" y="1196752"/>
            <a:ext cx="4582791" cy="4508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5514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6</Words>
  <Application>Microsoft Office PowerPoint</Application>
  <PresentationFormat>On-screen Show (4:3)</PresentationFormat>
  <Paragraphs>22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2</cp:revision>
  <dcterms:created xsi:type="dcterms:W3CDTF">2016-06-15T12:53:43Z</dcterms:created>
  <dcterms:modified xsi:type="dcterms:W3CDTF">2025-04-03T10:30:50Z</dcterms:modified>
</cp:coreProperties>
</file>